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5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704" y="192"/>
      </p:cViewPr>
      <p:guideLst>
        <p:guide orient="horz" pos="214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570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3940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755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342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4201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5983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7338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494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20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136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1429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2D6D6-013F-46F0-BA5D-16787A322A5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61827-C3CE-4027-A102-3170FC666B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23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400834" y="5391516"/>
            <a:ext cx="85427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ampling location of environmental DNA. A-line is the offshore area (light) and C-Line is the Bay area (left). </a:t>
            </a:r>
            <a:endParaRPr lang="ja-JP" altLang="ja-JP" sz="20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8A1BE573-C249-FF4E-A922-2756C2E434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54485"/>
            <a:ext cx="9144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6721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</TotalTime>
  <Words>26</Words>
  <Application>Microsoft Macintosh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ＭＳ 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uyama</dc:creator>
  <cp:lastModifiedBy>五十嵐洋治</cp:lastModifiedBy>
  <cp:revision>68</cp:revision>
  <dcterms:created xsi:type="dcterms:W3CDTF">2018-05-29T05:04:22Z</dcterms:created>
  <dcterms:modified xsi:type="dcterms:W3CDTF">2019-02-20T05:20:34Z</dcterms:modified>
</cp:coreProperties>
</file>